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30" autoAdjust="0"/>
    <p:restoredTop sz="94660"/>
  </p:normalViewPr>
  <p:slideViewPr>
    <p:cSldViewPr snapToGrid="0" showGuides="1">
      <p:cViewPr varScale="1">
        <p:scale>
          <a:sx n="94" d="100"/>
          <a:sy n="94" d="100"/>
        </p:scale>
        <p:origin x="86" y="307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B14A79B7-1543-4BC8-B10F-D329608A393E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123B072A-C331-4E22-B10F-95EFEDEF04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72111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45BFBA-3333-43A0-BADC-2A5481A111F6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8323DE-13CE-4AD0-B170-A19E4DAE6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54897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45BFBA-3333-43A0-BADC-2A5481A111F6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8323DE-13CE-4AD0-B170-A19E4DAE6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1205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45BFBA-3333-43A0-BADC-2A5481A111F6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8323DE-13CE-4AD0-B170-A19E4DAE6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66408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45BFBA-3333-43A0-BADC-2A5481A111F6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8323DE-13CE-4AD0-B170-A19E4DAE6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07976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45BFBA-3333-43A0-BADC-2A5481A111F6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8323DE-13CE-4AD0-B170-A19E4DAE6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47679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45BFBA-3333-43A0-BADC-2A5481A111F6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8323DE-13CE-4AD0-B170-A19E4DAE6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78909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45BFBA-3333-43A0-BADC-2A5481A111F6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8323DE-13CE-4AD0-B170-A19E4DAE6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22597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45BFBA-3333-43A0-BADC-2A5481A111F6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8323DE-13CE-4AD0-B170-A19E4DAE6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56799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45BFBA-3333-43A0-BADC-2A5481A111F6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8323DE-13CE-4AD0-B170-A19E4DAE6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35190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45BFBA-3333-43A0-BADC-2A5481A111F6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8323DE-13CE-4AD0-B170-A19E4DAE6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8080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45BFBA-3333-43A0-BADC-2A5481A111F6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8323DE-13CE-4AD0-B170-A19E4DAE6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00072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45BFBA-3333-43A0-BADC-2A5481A111F6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8323DE-13CE-4AD0-B170-A19E4DAE6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75137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3067" t="-1" r="10727" b="-1769"/>
          <a:stretch/>
        </p:blipFill>
        <p:spPr>
          <a:xfrm>
            <a:off x="633061" y="238538"/>
            <a:ext cx="1211510" cy="6535015"/>
          </a:xfrm>
          <a:prstGeom prst="rect">
            <a:avLst/>
          </a:prstGeom>
        </p:spPr>
      </p:pic>
      <p:sp>
        <p:nvSpPr>
          <p:cNvPr id="12" name="Rectangle 11"/>
          <p:cNvSpPr/>
          <p:nvPr/>
        </p:nvSpPr>
        <p:spPr>
          <a:xfrm rot="16200000">
            <a:off x="114219" y="1645324"/>
            <a:ext cx="77172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ormal</a:t>
            </a:r>
          </a:p>
        </p:txBody>
      </p:sp>
      <p:sp>
        <p:nvSpPr>
          <p:cNvPr id="15" name="Rectangle 14"/>
          <p:cNvSpPr/>
          <p:nvPr/>
        </p:nvSpPr>
        <p:spPr>
          <a:xfrm rot="16200000">
            <a:off x="93681" y="2641634"/>
            <a:ext cx="812804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ER2+</a:t>
            </a:r>
          </a:p>
        </p:txBody>
      </p:sp>
      <p:sp>
        <p:nvSpPr>
          <p:cNvPr id="18" name="Rectangle 17"/>
          <p:cNvSpPr/>
          <p:nvPr/>
        </p:nvSpPr>
        <p:spPr>
          <a:xfrm rot="16200000">
            <a:off x="124018" y="4886556"/>
            <a:ext cx="75212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uminal A</a:t>
            </a:r>
          </a:p>
        </p:txBody>
      </p:sp>
      <p:sp>
        <p:nvSpPr>
          <p:cNvPr id="19" name="Rectangle 18"/>
          <p:cNvSpPr/>
          <p:nvPr/>
        </p:nvSpPr>
        <p:spPr>
          <a:xfrm rot="16200000">
            <a:off x="124018" y="6012268"/>
            <a:ext cx="75212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uminal B</a:t>
            </a:r>
          </a:p>
        </p:txBody>
      </p:sp>
      <p:sp>
        <p:nvSpPr>
          <p:cNvPr id="20" name="Rectangle 19"/>
          <p:cNvSpPr/>
          <p:nvPr/>
        </p:nvSpPr>
        <p:spPr>
          <a:xfrm rot="16200000">
            <a:off x="233022" y="3798077"/>
            <a:ext cx="53412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NBC</a:t>
            </a:r>
          </a:p>
        </p:txBody>
      </p:sp>
      <p:sp>
        <p:nvSpPr>
          <p:cNvPr id="21" name="Rectangle 20"/>
          <p:cNvSpPr/>
          <p:nvPr/>
        </p:nvSpPr>
        <p:spPr>
          <a:xfrm rot="16200000">
            <a:off x="7618" y="578616"/>
            <a:ext cx="98492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ll subtypes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/>
          <a:srcRect t="2109"/>
          <a:stretch/>
        </p:blipFill>
        <p:spPr>
          <a:xfrm>
            <a:off x="3797076" y="128430"/>
            <a:ext cx="1820245" cy="6730146"/>
          </a:xfrm>
          <a:prstGeom prst="rect">
            <a:avLst/>
          </a:prstGeom>
        </p:spPr>
      </p:pic>
      <p:sp>
        <p:nvSpPr>
          <p:cNvPr id="22" name="Rectangle 21"/>
          <p:cNvSpPr/>
          <p:nvPr/>
        </p:nvSpPr>
        <p:spPr>
          <a:xfrm>
            <a:off x="901079" y="90499"/>
            <a:ext cx="77172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BLVRA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769BFBF-5D54-4FB2-BFBA-574B38596D2A}"/>
              </a:ext>
            </a:extLst>
          </p:cNvPr>
          <p:cNvSpPr txBox="1"/>
          <p:nvPr/>
        </p:nvSpPr>
        <p:spPr>
          <a:xfrm>
            <a:off x="72898" y="-18762"/>
            <a:ext cx="3820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769BFBF-5D54-4FB2-BFBA-574B38596D2A}"/>
              </a:ext>
            </a:extLst>
          </p:cNvPr>
          <p:cNvSpPr txBox="1"/>
          <p:nvPr/>
        </p:nvSpPr>
        <p:spPr>
          <a:xfrm>
            <a:off x="1864764" y="0"/>
            <a:ext cx="4180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9797365" y="6511443"/>
            <a:ext cx="22525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</a:p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N. Marchenko </a:t>
            </a:r>
            <a:r>
              <a:rPr lang="en-US" sz="800" b="1" u="sng" dirty="0">
                <a:latin typeface="Arial" panose="020B0604020202020204" pitchFamily="34" charset="0"/>
                <a:cs typeface="Arial" panose="020B0604020202020204" pitchFamily="34" charset="0"/>
              </a:rPr>
              <a:t>et. al.,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98932" y="111276"/>
            <a:ext cx="1804906" cy="6746724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00047" y="297055"/>
            <a:ext cx="1479407" cy="6472406"/>
          </a:xfrm>
          <a:prstGeom prst="rect">
            <a:avLst/>
          </a:prstGeom>
        </p:spPr>
      </p:pic>
      <p:sp>
        <p:nvSpPr>
          <p:cNvPr id="27" name="Rectangle 26"/>
          <p:cNvSpPr/>
          <p:nvPr/>
        </p:nvSpPr>
        <p:spPr>
          <a:xfrm>
            <a:off x="2563821" y="90499"/>
            <a:ext cx="77172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HMOX1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E769BFBF-5D54-4FB2-BFBA-574B38596D2A}"/>
              </a:ext>
            </a:extLst>
          </p:cNvPr>
          <p:cNvSpPr txBox="1"/>
          <p:nvPr/>
        </p:nvSpPr>
        <p:spPr>
          <a:xfrm>
            <a:off x="3628384" y="1758"/>
            <a:ext cx="4125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E769BFBF-5D54-4FB2-BFBA-574B38596D2A}"/>
              </a:ext>
            </a:extLst>
          </p:cNvPr>
          <p:cNvSpPr txBox="1"/>
          <p:nvPr/>
        </p:nvSpPr>
        <p:spPr>
          <a:xfrm>
            <a:off x="5653400" y="0"/>
            <a:ext cx="4504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</a:p>
        </p:txBody>
      </p:sp>
      <p:sp>
        <p:nvSpPr>
          <p:cNvPr id="43" name="Rectangle 42"/>
          <p:cNvSpPr/>
          <p:nvPr/>
        </p:nvSpPr>
        <p:spPr>
          <a:xfrm>
            <a:off x="6094542" y="48754"/>
            <a:ext cx="1654339" cy="215444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Overall Survival (</a:t>
            </a:r>
            <a:r>
              <a:rPr lang="en-U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HMOX1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60913C79-28A7-4F19-A8D1-512244447EE4}"/>
              </a:ext>
            </a:extLst>
          </p:cNvPr>
          <p:cNvSpPr txBox="1"/>
          <p:nvPr/>
        </p:nvSpPr>
        <p:spPr>
          <a:xfrm>
            <a:off x="1489250" y="900925"/>
            <a:ext cx="315792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.35 ± 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95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B5010163-6198-4B50-B10C-8254B715F90C}"/>
              </a:ext>
            </a:extLst>
          </p:cNvPr>
          <p:cNvSpPr txBox="1"/>
          <p:nvPr/>
        </p:nvSpPr>
        <p:spPr>
          <a:xfrm>
            <a:off x="6125995" y="1246104"/>
            <a:ext cx="75373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-value 0.97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R 1.02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898AFA84-44C2-4493-98D5-3B6E8B5639FB}"/>
              </a:ext>
            </a:extLst>
          </p:cNvPr>
          <p:cNvSpPr txBox="1"/>
          <p:nvPr/>
        </p:nvSpPr>
        <p:spPr>
          <a:xfrm>
            <a:off x="6125995" y="2934237"/>
            <a:ext cx="75373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-value 0.62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R 0.92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C423161C-CDC0-4434-B8CE-D84B6080CB05}"/>
              </a:ext>
            </a:extLst>
          </p:cNvPr>
          <p:cNvSpPr txBox="1"/>
          <p:nvPr/>
        </p:nvSpPr>
        <p:spPr>
          <a:xfrm>
            <a:off x="6125995" y="4632739"/>
            <a:ext cx="75373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-value 0.34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R 0.88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C6EC624D-C191-4CA9-85AE-4819379AA268}"/>
              </a:ext>
            </a:extLst>
          </p:cNvPr>
          <p:cNvSpPr txBox="1"/>
          <p:nvPr/>
        </p:nvSpPr>
        <p:spPr>
          <a:xfrm>
            <a:off x="6125995" y="6225092"/>
            <a:ext cx="75373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-value 0.70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R 1.03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4530CF0F-384D-46CB-94C1-074A54409B9C}"/>
              </a:ext>
            </a:extLst>
          </p:cNvPr>
          <p:cNvSpPr txBox="1"/>
          <p:nvPr/>
        </p:nvSpPr>
        <p:spPr>
          <a:xfrm>
            <a:off x="4041446" y="1246104"/>
            <a:ext cx="75373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-value 0.39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R 0.86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CE6FE306-2008-4BBA-8701-B1C8ED61FEE5}"/>
              </a:ext>
            </a:extLst>
          </p:cNvPr>
          <p:cNvSpPr txBox="1"/>
          <p:nvPr/>
        </p:nvSpPr>
        <p:spPr>
          <a:xfrm>
            <a:off x="4041446" y="2934237"/>
            <a:ext cx="75373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-value 0.03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R 0.67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8F13BB1D-D991-4012-A042-7D50C411206C}"/>
              </a:ext>
            </a:extLst>
          </p:cNvPr>
          <p:cNvSpPr txBox="1"/>
          <p:nvPr/>
        </p:nvSpPr>
        <p:spPr>
          <a:xfrm>
            <a:off x="4041446" y="4632739"/>
            <a:ext cx="75373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-value 0.01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R 0.72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3B9BDF06-C036-41FC-8DA6-669B4F80732B}"/>
              </a:ext>
            </a:extLst>
          </p:cNvPr>
          <p:cNvSpPr txBox="1"/>
          <p:nvPr/>
        </p:nvSpPr>
        <p:spPr>
          <a:xfrm>
            <a:off x="4041446" y="6225092"/>
            <a:ext cx="75373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-value 0.50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R 0.93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6EECF141-C048-4AF0-A1A2-35AE7BFEA9DB}"/>
              </a:ext>
            </a:extLst>
          </p:cNvPr>
          <p:cNvSpPr txBox="1"/>
          <p:nvPr/>
        </p:nvSpPr>
        <p:spPr>
          <a:xfrm>
            <a:off x="1489943" y="2023053"/>
            <a:ext cx="315792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.91 ± 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95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D9513A77-7C00-48F0-A90C-A3792027615A}"/>
              </a:ext>
            </a:extLst>
          </p:cNvPr>
          <p:cNvSpPr txBox="1"/>
          <p:nvPr/>
        </p:nvSpPr>
        <p:spPr>
          <a:xfrm>
            <a:off x="1489250" y="3063100"/>
            <a:ext cx="315792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.38 ± 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66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BCB329A8-A5FE-4514-BD06-EE9B1FCD0DC7}"/>
              </a:ext>
            </a:extLst>
          </p:cNvPr>
          <p:cNvSpPr txBox="1"/>
          <p:nvPr/>
        </p:nvSpPr>
        <p:spPr>
          <a:xfrm>
            <a:off x="1489668" y="4140176"/>
            <a:ext cx="315792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.31 ± 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77</a:t>
            </a:r>
          </a:p>
        </p:txBody>
      </p:sp>
      <p:sp>
        <p:nvSpPr>
          <p:cNvPr id="35" name="Rectangle 34"/>
          <p:cNvSpPr/>
          <p:nvPr/>
        </p:nvSpPr>
        <p:spPr>
          <a:xfrm>
            <a:off x="4011950" y="17977"/>
            <a:ext cx="1641449" cy="246221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Overall Survival (</a:t>
            </a:r>
            <a:r>
              <a:rPr lang="en-U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BLVRA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0DE20447-556A-4434-A67B-D76BF32CA8F5}"/>
              </a:ext>
            </a:extLst>
          </p:cNvPr>
          <p:cNvSpPr/>
          <p:nvPr/>
        </p:nvSpPr>
        <p:spPr>
          <a:xfrm rot="16200000">
            <a:off x="7348121" y="721874"/>
            <a:ext cx="812804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ER2+</a:t>
            </a:r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26A09D0E-BE41-4BEB-B32E-7729DF064C6D}"/>
              </a:ext>
            </a:extLst>
          </p:cNvPr>
          <p:cNvSpPr/>
          <p:nvPr/>
        </p:nvSpPr>
        <p:spPr>
          <a:xfrm rot="16200000">
            <a:off x="5228190" y="721874"/>
            <a:ext cx="812804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ER2+</a:t>
            </a: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1BB5BB91-E00E-430E-8D7B-E6B12834995F}"/>
              </a:ext>
            </a:extLst>
          </p:cNvPr>
          <p:cNvSpPr/>
          <p:nvPr/>
        </p:nvSpPr>
        <p:spPr>
          <a:xfrm rot="16200000">
            <a:off x="5367532" y="2508410"/>
            <a:ext cx="53412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NBC</a:t>
            </a:r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BCCC745D-93E3-4BA4-8A42-D14927628D71}"/>
              </a:ext>
            </a:extLst>
          </p:cNvPr>
          <p:cNvSpPr/>
          <p:nvPr/>
        </p:nvSpPr>
        <p:spPr>
          <a:xfrm rot="16200000">
            <a:off x="7487463" y="2508411"/>
            <a:ext cx="53412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NBC</a:t>
            </a:r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D515748C-0F06-413E-B531-54D4F55B14FB}"/>
              </a:ext>
            </a:extLst>
          </p:cNvPr>
          <p:cNvSpPr/>
          <p:nvPr/>
        </p:nvSpPr>
        <p:spPr>
          <a:xfrm rot="16200000">
            <a:off x="5258528" y="4274119"/>
            <a:ext cx="75212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uminal A</a:t>
            </a:r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F61851F1-9361-4912-B308-6BF1C27CF19C}"/>
              </a:ext>
            </a:extLst>
          </p:cNvPr>
          <p:cNvSpPr/>
          <p:nvPr/>
        </p:nvSpPr>
        <p:spPr>
          <a:xfrm rot="16200000">
            <a:off x="7378458" y="4274119"/>
            <a:ext cx="75212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uminal A</a:t>
            </a:r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81A1A32A-5B0C-4D6A-930F-D3F34AB39F48}"/>
              </a:ext>
            </a:extLst>
          </p:cNvPr>
          <p:cNvSpPr/>
          <p:nvPr/>
        </p:nvSpPr>
        <p:spPr>
          <a:xfrm rot="16200000">
            <a:off x="5258528" y="5891070"/>
            <a:ext cx="75212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uminal B</a:t>
            </a:r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E443D8ED-E090-49CD-ABD5-4022457191C2}"/>
              </a:ext>
            </a:extLst>
          </p:cNvPr>
          <p:cNvSpPr/>
          <p:nvPr/>
        </p:nvSpPr>
        <p:spPr>
          <a:xfrm rot="16200000">
            <a:off x="7378458" y="5891070"/>
            <a:ext cx="75212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uminal B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A2C1D551-FFFB-4380-9A14-934B7A5DA525}"/>
              </a:ext>
            </a:extLst>
          </p:cNvPr>
          <p:cNvSpPr/>
          <p:nvPr/>
        </p:nvSpPr>
        <p:spPr>
          <a:xfrm>
            <a:off x="4418312" y="1814048"/>
            <a:ext cx="678599" cy="12086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AEF574C6-45E8-472A-9B34-8AF776F64AA2}"/>
              </a:ext>
            </a:extLst>
          </p:cNvPr>
          <p:cNvSpPr/>
          <p:nvPr/>
        </p:nvSpPr>
        <p:spPr>
          <a:xfrm>
            <a:off x="6580487" y="1804523"/>
            <a:ext cx="678599" cy="12086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2EA5CE98-54B2-4C47-81DD-888E4E3272DF}"/>
              </a:ext>
            </a:extLst>
          </p:cNvPr>
          <p:cNvSpPr/>
          <p:nvPr/>
        </p:nvSpPr>
        <p:spPr>
          <a:xfrm>
            <a:off x="4383959" y="3486975"/>
            <a:ext cx="678599" cy="12086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Rectangle 61">
            <a:extLst>
              <a:ext uri="{FF2B5EF4-FFF2-40B4-BE49-F238E27FC236}">
                <a16:creationId xmlns:a16="http://schemas.microsoft.com/office/drawing/2014/main" id="{3617149B-2A24-41B0-9118-334C4225C8AC}"/>
              </a:ext>
            </a:extLst>
          </p:cNvPr>
          <p:cNvSpPr/>
          <p:nvPr/>
        </p:nvSpPr>
        <p:spPr>
          <a:xfrm>
            <a:off x="6442835" y="3474185"/>
            <a:ext cx="678599" cy="12086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F72966E6-BF0B-4830-8071-09E52C586AE8}"/>
              </a:ext>
            </a:extLst>
          </p:cNvPr>
          <p:cNvSpPr/>
          <p:nvPr/>
        </p:nvSpPr>
        <p:spPr>
          <a:xfrm>
            <a:off x="4475462" y="5166848"/>
            <a:ext cx="678599" cy="12086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Rectangle 63">
            <a:extLst>
              <a:ext uri="{FF2B5EF4-FFF2-40B4-BE49-F238E27FC236}">
                <a16:creationId xmlns:a16="http://schemas.microsoft.com/office/drawing/2014/main" id="{E51246BD-C0A7-4A7B-A4A5-C90C75A6B85E}"/>
              </a:ext>
            </a:extLst>
          </p:cNvPr>
          <p:cNvSpPr/>
          <p:nvPr/>
        </p:nvSpPr>
        <p:spPr>
          <a:xfrm>
            <a:off x="6409037" y="5157323"/>
            <a:ext cx="678599" cy="12086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EFA254D1-1073-41B8-A3D6-2819C110934F}"/>
              </a:ext>
            </a:extLst>
          </p:cNvPr>
          <p:cNvSpPr txBox="1"/>
          <p:nvPr/>
        </p:nvSpPr>
        <p:spPr>
          <a:xfrm>
            <a:off x="1489668" y="5204484"/>
            <a:ext cx="315792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.59 ± 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82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67564880-DBFE-4EA2-B3EE-F8945ED2F632}"/>
              </a:ext>
            </a:extLst>
          </p:cNvPr>
          <p:cNvSpPr txBox="1"/>
          <p:nvPr/>
        </p:nvSpPr>
        <p:spPr>
          <a:xfrm>
            <a:off x="1489250" y="6257584"/>
            <a:ext cx="315792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.81 ± 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80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FEFE678A-B76F-4CB8-A7BD-761C0EF95C4F}"/>
              </a:ext>
            </a:extLst>
          </p:cNvPr>
          <p:cNvSpPr txBox="1"/>
          <p:nvPr/>
        </p:nvSpPr>
        <p:spPr>
          <a:xfrm>
            <a:off x="3080572" y="900925"/>
            <a:ext cx="315792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.88 ± 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.01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AB55E891-E6D4-4EAB-8BE2-B6047156D44B}"/>
              </a:ext>
            </a:extLst>
          </p:cNvPr>
          <p:cNvSpPr txBox="1"/>
          <p:nvPr/>
        </p:nvSpPr>
        <p:spPr>
          <a:xfrm>
            <a:off x="3080572" y="2023053"/>
            <a:ext cx="315792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.01 ± 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.97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24EE38B3-469E-4650-B841-AD4BA65990D6}"/>
              </a:ext>
            </a:extLst>
          </p:cNvPr>
          <p:cNvSpPr txBox="1"/>
          <p:nvPr/>
        </p:nvSpPr>
        <p:spPr>
          <a:xfrm>
            <a:off x="3080572" y="3063100"/>
            <a:ext cx="315792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.04 ± 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88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4398BB52-F4CC-4497-87ED-1A48FA65AA36}"/>
              </a:ext>
            </a:extLst>
          </p:cNvPr>
          <p:cNvSpPr txBox="1"/>
          <p:nvPr/>
        </p:nvSpPr>
        <p:spPr>
          <a:xfrm>
            <a:off x="3080572" y="4140176"/>
            <a:ext cx="315792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.87 ± 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.09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E80A4E49-8C95-4107-888D-BAD7350176B1}"/>
              </a:ext>
            </a:extLst>
          </p:cNvPr>
          <p:cNvSpPr txBox="1"/>
          <p:nvPr/>
        </p:nvSpPr>
        <p:spPr>
          <a:xfrm>
            <a:off x="3080572" y="5204484"/>
            <a:ext cx="315792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.81 ± 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98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BF4E912E-B405-457D-943C-1F452D8277C7}"/>
              </a:ext>
            </a:extLst>
          </p:cNvPr>
          <p:cNvSpPr txBox="1"/>
          <p:nvPr/>
        </p:nvSpPr>
        <p:spPr>
          <a:xfrm>
            <a:off x="3080572" y="6257584"/>
            <a:ext cx="315792" cy="246221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.06 ± 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95</a:t>
            </a:r>
          </a:p>
        </p:txBody>
      </p:sp>
      <p:pic>
        <p:nvPicPr>
          <p:cNvPr id="76" name="Picture 75">
            <a:extLst>
              <a:ext uri="{FF2B5EF4-FFF2-40B4-BE49-F238E27FC236}">
                <a16:creationId xmlns:a16="http://schemas.microsoft.com/office/drawing/2014/main" id="{47BCDC77-16ED-4712-A90A-0E99D868BA21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8929" t="24608" b="50081"/>
          <a:stretch/>
        </p:blipFill>
        <p:spPr>
          <a:xfrm>
            <a:off x="8097627" y="158917"/>
            <a:ext cx="1897527" cy="1752501"/>
          </a:xfrm>
          <a:prstGeom prst="rect">
            <a:avLst/>
          </a:prstGeom>
        </p:spPr>
      </p:pic>
      <p:pic>
        <p:nvPicPr>
          <p:cNvPr id="77" name="Picture 76">
            <a:extLst>
              <a:ext uri="{FF2B5EF4-FFF2-40B4-BE49-F238E27FC236}">
                <a16:creationId xmlns:a16="http://schemas.microsoft.com/office/drawing/2014/main" id="{ABB21079-045D-4592-B0A8-BC3E5C160CA7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8929" t="50761"/>
          <a:stretch/>
        </p:blipFill>
        <p:spPr>
          <a:xfrm>
            <a:off x="8150537" y="1969111"/>
            <a:ext cx="1902283" cy="3417845"/>
          </a:xfrm>
          <a:prstGeom prst="rect">
            <a:avLst/>
          </a:prstGeom>
        </p:spPr>
      </p:pic>
      <p:sp>
        <p:nvSpPr>
          <p:cNvPr id="79" name="TextBox 78">
            <a:extLst>
              <a:ext uri="{FF2B5EF4-FFF2-40B4-BE49-F238E27FC236}">
                <a16:creationId xmlns:a16="http://schemas.microsoft.com/office/drawing/2014/main" id="{6297507C-98C9-4AA7-BAD0-78229A6EFDF3}"/>
              </a:ext>
            </a:extLst>
          </p:cNvPr>
          <p:cNvSpPr txBox="1"/>
          <p:nvPr/>
        </p:nvSpPr>
        <p:spPr>
          <a:xfrm>
            <a:off x="8386239" y="1327599"/>
            <a:ext cx="75373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-value 0.83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R 0.96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7E52E507-28C7-4C1E-9726-E3E52A22BE4F}"/>
              </a:ext>
            </a:extLst>
          </p:cNvPr>
          <p:cNvSpPr txBox="1"/>
          <p:nvPr/>
        </p:nvSpPr>
        <p:spPr>
          <a:xfrm>
            <a:off x="8430141" y="3002985"/>
            <a:ext cx="75373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-value 0.74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R 0.97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D58C3B14-C984-4958-9EF6-E21FA9E4B52C}"/>
              </a:ext>
            </a:extLst>
          </p:cNvPr>
          <p:cNvSpPr txBox="1"/>
          <p:nvPr/>
        </p:nvSpPr>
        <p:spPr>
          <a:xfrm>
            <a:off x="8423577" y="4685476"/>
            <a:ext cx="75373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-value 0.35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R 1.13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DBAF8A4E-829C-4518-B903-F1A9236AAE64}"/>
              </a:ext>
            </a:extLst>
          </p:cNvPr>
          <p:cNvSpPr txBox="1"/>
          <p:nvPr/>
        </p:nvSpPr>
        <p:spPr>
          <a:xfrm>
            <a:off x="9903994" y="240606"/>
            <a:ext cx="710451" cy="33855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8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LVRB</a:t>
            </a:r>
            <a:r>
              <a:rPr lang="en-US" sz="800" baseline="300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  <a:endParaRPr lang="en-US" sz="800" baseline="30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800" dirty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800" dirty="0" err="1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BLVRB</a:t>
            </a:r>
            <a:r>
              <a:rPr lang="en-US" sz="800" baseline="30000" dirty="0" err="1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endParaRPr lang="en-US" sz="800" baseline="30000" dirty="0">
              <a:solidFill>
                <a:schemeClr val="accent6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Rectangle 87">
            <a:extLst>
              <a:ext uri="{FF2B5EF4-FFF2-40B4-BE49-F238E27FC236}">
                <a16:creationId xmlns:a16="http://schemas.microsoft.com/office/drawing/2014/main" id="{605D440C-1CF4-4A19-8206-CEBD6F5FB335}"/>
              </a:ext>
            </a:extLst>
          </p:cNvPr>
          <p:cNvSpPr/>
          <p:nvPr/>
        </p:nvSpPr>
        <p:spPr>
          <a:xfrm>
            <a:off x="9052961" y="326134"/>
            <a:ext cx="820336" cy="15303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9" name="Rectangle 88">
            <a:extLst>
              <a:ext uri="{FF2B5EF4-FFF2-40B4-BE49-F238E27FC236}">
                <a16:creationId xmlns:a16="http://schemas.microsoft.com/office/drawing/2014/main" id="{F9CBEF51-209D-4DB0-8AC8-C1E59CB2A097}"/>
              </a:ext>
            </a:extLst>
          </p:cNvPr>
          <p:cNvSpPr/>
          <p:nvPr/>
        </p:nvSpPr>
        <p:spPr>
          <a:xfrm>
            <a:off x="8999960" y="1997602"/>
            <a:ext cx="731520" cy="14630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0" name="Rectangle 89">
            <a:extLst>
              <a:ext uri="{FF2B5EF4-FFF2-40B4-BE49-F238E27FC236}">
                <a16:creationId xmlns:a16="http://schemas.microsoft.com/office/drawing/2014/main" id="{C9B896F5-FBE4-4DE7-9D66-F19C979DD44A}"/>
              </a:ext>
            </a:extLst>
          </p:cNvPr>
          <p:cNvSpPr/>
          <p:nvPr/>
        </p:nvSpPr>
        <p:spPr>
          <a:xfrm>
            <a:off x="8990132" y="3510816"/>
            <a:ext cx="731520" cy="14630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1" name="Rectangle 90">
            <a:extLst>
              <a:ext uri="{FF2B5EF4-FFF2-40B4-BE49-F238E27FC236}">
                <a16:creationId xmlns:a16="http://schemas.microsoft.com/office/drawing/2014/main" id="{BCCC745D-93E3-4BA4-8A42-D14927628D71}"/>
              </a:ext>
            </a:extLst>
          </p:cNvPr>
          <p:cNvSpPr/>
          <p:nvPr/>
        </p:nvSpPr>
        <p:spPr>
          <a:xfrm rot="16200000">
            <a:off x="9747575" y="914152"/>
            <a:ext cx="53412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NBC</a:t>
            </a:r>
          </a:p>
        </p:txBody>
      </p:sp>
      <p:sp>
        <p:nvSpPr>
          <p:cNvPr id="92" name="Rectangle 91">
            <a:extLst>
              <a:ext uri="{FF2B5EF4-FFF2-40B4-BE49-F238E27FC236}">
                <a16:creationId xmlns:a16="http://schemas.microsoft.com/office/drawing/2014/main" id="{F61851F1-9361-4912-B308-6BF1C27CF19C}"/>
              </a:ext>
            </a:extLst>
          </p:cNvPr>
          <p:cNvSpPr/>
          <p:nvPr/>
        </p:nvSpPr>
        <p:spPr>
          <a:xfrm rot="16200000">
            <a:off x="9671522" y="2679860"/>
            <a:ext cx="75212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uminal A</a:t>
            </a:r>
          </a:p>
        </p:txBody>
      </p:sp>
      <p:sp>
        <p:nvSpPr>
          <p:cNvPr id="93" name="Rectangle 92">
            <a:extLst>
              <a:ext uri="{FF2B5EF4-FFF2-40B4-BE49-F238E27FC236}">
                <a16:creationId xmlns:a16="http://schemas.microsoft.com/office/drawing/2014/main" id="{E443D8ED-E090-49CD-ABD5-4022457191C2}"/>
              </a:ext>
            </a:extLst>
          </p:cNvPr>
          <p:cNvSpPr/>
          <p:nvPr/>
        </p:nvSpPr>
        <p:spPr>
          <a:xfrm rot="16200000">
            <a:off x="9671522" y="4296811"/>
            <a:ext cx="75212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uminal B</a:t>
            </a:r>
          </a:p>
        </p:txBody>
      </p:sp>
      <p:sp>
        <p:nvSpPr>
          <p:cNvPr id="94" name="Rectangle 93"/>
          <p:cNvSpPr/>
          <p:nvPr/>
        </p:nvSpPr>
        <p:spPr>
          <a:xfrm>
            <a:off x="8499326" y="6019407"/>
            <a:ext cx="545445" cy="26623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5" name="Rectangle 94"/>
          <p:cNvSpPr/>
          <p:nvPr/>
        </p:nvSpPr>
        <p:spPr>
          <a:xfrm>
            <a:off x="8430100" y="48754"/>
            <a:ext cx="1654339" cy="215444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Overall Survival (</a:t>
            </a:r>
            <a:r>
              <a:rPr lang="en-U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BLVRB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769BFBF-5D54-4FB2-BFBA-574B38596D2A}"/>
              </a:ext>
            </a:extLst>
          </p:cNvPr>
          <p:cNvSpPr txBox="1"/>
          <p:nvPr/>
        </p:nvSpPr>
        <p:spPr>
          <a:xfrm>
            <a:off x="7929587" y="-14202"/>
            <a:ext cx="4504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.</a:t>
            </a:r>
          </a:p>
        </p:txBody>
      </p:sp>
    </p:spTree>
    <p:extLst>
      <p:ext uri="{BB962C8B-B14F-4D97-AF65-F5344CB8AC3E}">
        <p14:creationId xmlns:p14="http://schemas.microsoft.com/office/powerpoint/2010/main" val="8519842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07</TotalTime>
  <Words>152</Words>
  <Application>Microsoft Office PowerPoint</Application>
  <PresentationFormat>Widescreen</PresentationFormat>
  <Paragraphs>7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talia</dc:creator>
  <cp:lastModifiedBy>Natalia</cp:lastModifiedBy>
  <cp:revision>27</cp:revision>
  <cp:lastPrinted>2025-05-06T14:42:02Z</cp:lastPrinted>
  <dcterms:created xsi:type="dcterms:W3CDTF">2024-11-09T17:57:25Z</dcterms:created>
  <dcterms:modified xsi:type="dcterms:W3CDTF">2025-08-14T15:29:47Z</dcterms:modified>
</cp:coreProperties>
</file>